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1914" y="7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ED3B11-17F7-4F31-84E1-7EBD31203EA8}" type="datetimeFigureOut">
              <a:rPr lang="de-DE" smtClean="0"/>
              <a:t>09.12.20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CC3BAC-598D-4AD5-A974-81313C07F2B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2994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482E-4ABA-4110-961C-20581CE9ACC2}" type="datetimeFigureOut">
              <a:rPr lang="de-DE" smtClean="0"/>
              <a:t>09.1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43B9E-D102-4957-92C0-A616FD31FE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47680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482E-4ABA-4110-961C-20581CE9ACC2}" type="datetimeFigureOut">
              <a:rPr lang="de-DE" smtClean="0"/>
              <a:t>09.1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43B9E-D102-4957-92C0-A616FD31FE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79957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482E-4ABA-4110-961C-20581CE9ACC2}" type="datetimeFigureOut">
              <a:rPr lang="de-DE" smtClean="0"/>
              <a:t>09.1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43B9E-D102-4957-92C0-A616FD31FE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9231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482E-4ABA-4110-961C-20581CE9ACC2}" type="datetimeFigureOut">
              <a:rPr lang="de-DE" smtClean="0"/>
              <a:t>09.1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43B9E-D102-4957-92C0-A616FD31FE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77061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482E-4ABA-4110-961C-20581CE9ACC2}" type="datetimeFigureOut">
              <a:rPr lang="de-DE" smtClean="0"/>
              <a:t>09.1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43B9E-D102-4957-92C0-A616FD31FE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2016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482E-4ABA-4110-961C-20581CE9ACC2}" type="datetimeFigureOut">
              <a:rPr lang="de-DE" smtClean="0"/>
              <a:t>09.12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43B9E-D102-4957-92C0-A616FD31FE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15245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482E-4ABA-4110-961C-20581CE9ACC2}" type="datetimeFigureOut">
              <a:rPr lang="de-DE" smtClean="0"/>
              <a:t>09.12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43B9E-D102-4957-92C0-A616FD31FE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486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482E-4ABA-4110-961C-20581CE9ACC2}" type="datetimeFigureOut">
              <a:rPr lang="de-DE" smtClean="0"/>
              <a:t>09.12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43B9E-D102-4957-92C0-A616FD31FE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65882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482E-4ABA-4110-961C-20581CE9ACC2}" type="datetimeFigureOut">
              <a:rPr lang="de-DE" smtClean="0"/>
              <a:t>09.12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43B9E-D102-4957-92C0-A616FD31FE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71940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482E-4ABA-4110-961C-20581CE9ACC2}" type="datetimeFigureOut">
              <a:rPr lang="de-DE" smtClean="0"/>
              <a:t>09.12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43B9E-D102-4957-92C0-A616FD31FE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18806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3482E-4ABA-4110-961C-20581CE9ACC2}" type="datetimeFigureOut">
              <a:rPr lang="de-DE" smtClean="0"/>
              <a:t>09.12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43B9E-D102-4957-92C0-A616FD31FE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7823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E3482E-4ABA-4110-961C-20581CE9ACC2}" type="datetimeFigureOut">
              <a:rPr lang="de-DE" smtClean="0"/>
              <a:t>09.1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F43B9E-D102-4957-92C0-A616FD31FE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08679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>
            <a:extLst>
              <a:ext uri="{FF2B5EF4-FFF2-40B4-BE49-F238E27FC236}">
                <a16:creationId xmlns:a16="http://schemas.microsoft.com/office/drawing/2014/main" id="{A32D74E5-7F76-4A15-BB0A-DD14F584C5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04918" y="169698"/>
            <a:ext cx="7315834" cy="5755123"/>
          </a:xfrm>
          <a:prstGeom prst="rect">
            <a:avLst/>
          </a:prstGeom>
        </p:spPr>
      </p:pic>
      <p:sp>
        <p:nvSpPr>
          <p:cNvPr id="8" name="Textfeld 7">
            <a:extLst>
              <a:ext uri="{FF2B5EF4-FFF2-40B4-BE49-F238E27FC236}">
                <a16:creationId xmlns:a16="http://schemas.microsoft.com/office/drawing/2014/main" id="{1AD478F7-2290-4076-82D3-9B1E0D8857E0}"/>
              </a:ext>
            </a:extLst>
          </p:cNvPr>
          <p:cNvSpPr txBox="1"/>
          <p:nvPr/>
        </p:nvSpPr>
        <p:spPr>
          <a:xfrm>
            <a:off x="2571248" y="5702880"/>
            <a:ext cx="704950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Fig. S1: Data from the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Siemens Biograph 64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</a:rPr>
              <a:t>TruePoint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PET/CT scanner.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Line plots of volume-reproducing threshold (VRT) against signal-to-background ratio (SBR) for 6 sphere diameters, VRT difference between wall-less and fillable spheres, and the resulting difference of segmented volumes. pp: percentage points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27003938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Klinikum der Universitaet Muench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dzounek</dc:creator>
  <cp:lastModifiedBy>Zounek, Adrian Jun</cp:lastModifiedBy>
  <cp:revision>24</cp:revision>
  <dcterms:created xsi:type="dcterms:W3CDTF">2024-03-06T10:34:05Z</dcterms:created>
  <dcterms:modified xsi:type="dcterms:W3CDTF">2024-12-09T14:50:52Z</dcterms:modified>
</cp:coreProperties>
</file>